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9.jpeg" ContentType="image/jpeg"/>
  <Override PartName="/ppt/media/image4.jpeg" ContentType="image/jpeg"/>
  <Override PartName="/ppt/media/image5.jpeg" ContentType="image/jpe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1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FDDA5-D24A-49DE-91B7-CBD9617A96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4941C-87E6-46A5-BF89-7EC7445BBF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6E319-A55A-4328-8977-7E46559D04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A7AF6-DAD3-40CB-9A39-B51E15EE7B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FF7B1-F9E2-42CE-8EF0-3AFBA03A21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5B931-3C90-4F04-AA24-4C76F84DB6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99AD3-7A89-4D76-B3CE-854280A070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AB6FE-C9A7-4C6B-87CC-A17F801C9A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BF7A2F-D90E-41CB-81C2-0ACB08BBB8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1B461-36A4-453C-B27A-C67D72E8EE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62C4F-BA65-4501-B9DA-EA80DBB0EB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22D3C-E675-493C-A3FD-C9D410F416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55D72F4-1DA9-41DD-B60A-B861311989A1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CB50774-D9B4-47B1-9686-228AE76F8A9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jpe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6"/>
          <p:cNvSpPr/>
          <p:nvPr/>
        </p:nvSpPr>
        <p:spPr>
          <a:xfrm>
            <a:off x="317520" y="730080"/>
            <a:ext cx="44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3"/>
          <p:cNvGrpSpPr/>
          <p:nvPr/>
        </p:nvGrpSpPr>
        <p:grpSpPr>
          <a:xfrm>
            <a:off x="2712960" y="1035000"/>
            <a:ext cx="6215040" cy="5300640"/>
            <a:chOff x="2712960" y="1035000"/>
            <a:chExt cx="6215040" cy="5300640"/>
          </a:xfrm>
        </p:grpSpPr>
        <p:grpSp>
          <p:nvGrpSpPr>
            <p:cNvPr id="43" name="Group 7"/>
            <p:cNvGrpSpPr/>
            <p:nvPr/>
          </p:nvGrpSpPr>
          <p:grpSpPr>
            <a:xfrm>
              <a:off x="5937840" y="1297440"/>
              <a:ext cx="2940120" cy="2367000"/>
              <a:chOff x="5937840" y="1297440"/>
              <a:chExt cx="2940120" cy="2367000"/>
            </a:xfrm>
          </p:grpSpPr>
          <p:pic>
            <p:nvPicPr>
              <p:cNvPr id="44" name="Chart 4" descr=""/>
              <p:cNvPicPr/>
              <p:nvPr/>
            </p:nvPicPr>
            <p:blipFill>
              <a:blip r:embed="rId1"/>
              <a:stretch/>
            </p:blipFill>
            <p:spPr>
              <a:xfrm>
                <a:off x="6247800" y="1297440"/>
                <a:ext cx="2630160" cy="2113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TextBox 5"/>
              <p:cNvSpPr/>
              <p:nvPr/>
            </p:nvSpPr>
            <p:spPr>
              <a:xfrm>
                <a:off x="6860520" y="3403080"/>
                <a:ext cx="18342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Relative virus inoculum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Box 6"/>
              <p:cNvSpPr/>
              <p:nvPr/>
            </p:nvSpPr>
            <p:spPr>
              <a:xfrm rot="16200000">
                <a:off x="5467680" y="1961640"/>
                <a:ext cx="1536120" cy="59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Relative inhibition (HCV/normal serum)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7" name="TextBox 8"/>
            <p:cNvSpPr/>
            <p:nvPr/>
          </p:nvSpPr>
          <p:spPr>
            <a:xfrm>
              <a:off x="2712960" y="3868920"/>
              <a:ext cx="6215040" cy="246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4. (A) Adjacent location of lipid droplets and HCV NS5A in live BHK-WNV cell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CVbp-4cys-coding plasmid was transfected into BHK-WNV cells. Three days later, live cells were incubated with ReAsH (top panel), and with BODIPY 493/503 to detect lipid droplets (LD) (middle panel). Accumulation of LD could be observed in the vicinity of ReAsH-stained HCV protein (white arrows) (bottom panel)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B) inhibition of HCVbp infectivity by immune human serum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fter their 1 hr incubation with either normal human serum (open squares) or from an HCV-cured patient (closed circles), HCVbp were incubated for another 2 hr with Huh-7.5 cells seeded onto collagen-I-coated 24-well plates. After several washes, cells were further cultured for two days, harvested and HCV RNA was subjected to RT-qPCR analysis</a:t>
              </a:r>
              <a:r>
                <a:rPr b="0" lang="en-US" sz="1200" spc="-1" strike="noStrike">
                  <a:solidFill>
                    <a:srgbClr val="0000ff"/>
                  </a:solidFill>
                  <a:latin typeface="Arial"/>
                </a:rPr>
                <a:t>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he limit of detection in this assay is indicated by a dotted line; nd = undetermined. The ratios of intracellular amounts of HCV RNA obtained with each of the two sera were calculated (right panel); errors bars represent SD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Chart 20" descr=""/>
            <p:cNvPicPr/>
            <p:nvPr/>
          </p:nvPicPr>
          <p:blipFill>
            <a:blip r:embed="rId2"/>
            <a:stretch/>
          </p:blipFill>
          <p:spPr>
            <a:xfrm>
              <a:off x="2852640" y="1035000"/>
              <a:ext cx="2993040" cy="278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21"/>
            <p:cNvSpPr/>
            <p:nvPr/>
          </p:nvSpPr>
          <p:spPr>
            <a:xfrm>
              <a:off x="3097080" y="1099800"/>
              <a:ext cx="485640" cy="211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Aft>
                  <a:spcPts val="3699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spcAft>
                  <a:spcPts val="3699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spcAft>
                  <a:spcPts val="3699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spcAft>
                  <a:spcPts val="3699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22"/>
            <p:cNvSpPr/>
            <p:nvPr/>
          </p:nvSpPr>
          <p:spPr>
            <a:xfrm>
              <a:off x="3271680" y="2877840"/>
              <a:ext cx="2422440" cy="824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25"/>
            <p:cNvSpPr/>
            <p:nvPr/>
          </p:nvSpPr>
          <p:spPr>
            <a:xfrm>
              <a:off x="3614400" y="2920680"/>
              <a:ext cx="2065320" cy="1440"/>
            </a:xfrm>
            <a:prstGeom prst="line">
              <a:avLst/>
            </a:prstGeom>
            <a:ln w="1260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Group 26"/>
          <p:cNvGrpSpPr/>
          <p:nvPr/>
        </p:nvGrpSpPr>
        <p:grpSpPr>
          <a:xfrm>
            <a:off x="655560" y="819000"/>
            <a:ext cx="1836720" cy="5562720"/>
            <a:chOff x="655560" y="819000"/>
            <a:chExt cx="1836720" cy="5562720"/>
          </a:xfrm>
        </p:grpSpPr>
        <p:pic>
          <p:nvPicPr>
            <p:cNvPr id="53" name="Picture 2" descr="HCV-CT-ReASH-LD g_z0_ch02.jpg"/>
            <p:cNvPicPr/>
            <p:nvPr/>
          </p:nvPicPr>
          <p:blipFill>
            <a:blip r:embed="rId3"/>
            <a:stretch/>
          </p:blipFill>
          <p:spPr>
            <a:xfrm>
              <a:off x="663480" y="81900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4"/>
            <p:cNvSpPr/>
            <p:nvPr/>
          </p:nvSpPr>
          <p:spPr>
            <a:xfrm>
              <a:off x="692280" y="2353320"/>
              <a:ext cx="66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</a:rPr>
                <a:t>ReAs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5" name="Picture 1" descr="HCV-CT-ReASH-LD g_z0_ch00.jpg"/>
            <p:cNvPicPr/>
            <p:nvPr/>
          </p:nvPicPr>
          <p:blipFill>
            <a:blip r:embed="rId4"/>
            <a:stretch/>
          </p:blipFill>
          <p:spPr>
            <a:xfrm>
              <a:off x="662040" y="268596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5"/>
            <p:cNvSpPr/>
            <p:nvPr/>
          </p:nvSpPr>
          <p:spPr>
            <a:xfrm>
              <a:off x="686520" y="4238280"/>
              <a:ext cx="37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ff00"/>
                  </a:solidFill>
                  <a:latin typeface="Arial"/>
                </a:rPr>
                <a:t>L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Picture 3" descr="HCV-CT-ReASH-LD gSnapshot1.jpg"/>
            <p:cNvPicPr/>
            <p:nvPr/>
          </p:nvPicPr>
          <p:blipFill>
            <a:blip r:embed="rId5"/>
            <a:stretch/>
          </p:blipFill>
          <p:spPr>
            <a:xfrm>
              <a:off x="655560" y="455292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Box 6"/>
            <p:cNvSpPr/>
            <p:nvPr/>
          </p:nvSpPr>
          <p:spPr>
            <a:xfrm>
              <a:off x="683280" y="608760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ccffcc"/>
                  </a:solidFill>
                  <a:latin typeface="Arial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9" name="Straight Arrow Connector 12"/>
            <p:cNvCxnSpPr/>
            <p:nvPr/>
          </p:nvCxnSpPr>
          <p:spPr>
            <a:xfrm>
              <a:off x="858600" y="4627440"/>
              <a:ext cx="127440" cy="28944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med" type="arrow" w="med"/>
            </a:ln>
          </p:spPr>
        </p:cxnSp>
        <p:cxnSp>
          <p:nvCxnSpPr>
            <p:cNvPr id="60" name="Straight Arrow Connector 13"/>
            <p:cNvCxnSpPr/>
            <p:nvPr/>
          </p:nvCxnSpPr>
          <p:spPr>
            <a:xfrm>
              <a:off x="1252440" y="4649400"/>
              <a:ext cx="127440" cy="28764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med" type="arrow" w="med"/>
            </a:ln>
          </p:spPr>
        </p:cxnSp>
      </p:grpSp>
      <p:sp>
        <p:nvSpPr>
          <p:cNvPr id="61" name="TextBox 56"/>
          <p:cNvSpPr/>
          <p:nvPr/>
        </p:nvSpPr>
        <p:spPr>
          <a:xfrm>
            <a:off x="2701800" y="730080"/>
            <a:ext cx="44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Group 27"/>
          <p:cNvGrpSpPr/>
          <p:nvPr/>
        </p:nvGrpSpPr>
        <p:grpSpPr>
          <a:xfrm>
            <a:off x="380880" y="422280"/>
            <a:ext cx="8382240" cy="6114960"/>
            <a:chOff x="380880" y="422280"/>
            <a:chExt cx="8382240" cy="6114960"/>
          </a:xfrm>
        </p:grpSpPr>
        <p:sp>
          <p:nvSpPr>
            <p:cNvPr id="63" name="TextBox 32"/>
            <p:cNvSpPr/>
            <p:nvPr/>
          </p:nvSpPr>
          <p:spPr>
            <a:xfrm>
              <a:off x="380880" y="5165640"/>
              <a:ext cx="8382240" cy="1371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. S4 (C)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-house HCV NS5A rabbit polyclonal antibody recognizes NS5A-expressing cell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left panel) Huh-7.5 cells were incubated with HCVbp for 2 hr, then virus inoculum was removed. Two days later, cells were analyzed for NS5A expression using in-house NS5A rabbit polyclonal antibody. Huh-7.5 cell line bearing subgenomic replicon of genotype 1a was used as a positive control (middle panel). The signal abolished after incubating antibody with immunizing polypeptide (not shown)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D) HCVbp-4cys infection of Huh-7.5 cell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uh-7.5 cells were infected with HCVbp-4cys (HCVbp encoding tetracysteine tag). Three days later, live cells were incubated with FIAsH or ReAsH (cell-permeant biarsenical dyes binding to the tag)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4" name="Group 33"/>
            <p:cNvGrpSpPr/>
            <p:nvPr/>
          </p:nvGrpSpPr>
          <p:grpSpPr>
            <a:xfrm>
              <a:off x="1522440" y="422280"/>
              <a:ext cx="6099120" cy="4576680"/>
              <a:chOff x="1522440" y="422280"/>
              <a:chExt cx="6099120" cy="4576680"/>
            </a:xfrm>
          </p:grpSpPr>
          <p:sp>
            <p:nvSpPr>
              <p:cNvPr id="65" name="TextBox 5"/>
              <p:cNvSpPr/>
              <p:nvPr/>
            </p:nvSpPr>
            <p:spPr>
              <a:xfrm>
                <a:off x="1525320" y="42228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6" name="Group 34"/>
              <p:cNvGrpSpPr/>
              <p:nvPr/>
            </p:nvGrpSpPr>
            <p:grpSpPr>
              <a:xfrm>
                <a:off x="2070000" y="457200"/>
                <a:ext cx="5499360" cy="2089080"/>
                <a:chOff x="2070000" y="457200"/>
                <a:chExt cx="5499360" cy="2089080"/>
              </a:xfrm>
            </p:grpSpPr>
            <p:pic>
              <p:nvPicPr>
                <p:cNvPr id="67" name="Picture 4" descr="050808_1arep-NS5A4_z000_ch00-deconvolved_001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3930120" y="751680"/>
                  <a:ext cx="1794600" cy="1794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8" name="Text Box 9"/>
                <p:cNvSpPr/>
                <p:nvPr/>
              </p:nvSpPr>
              <p:spPr>
                <a:xfrm>
                  <a:off x="5118480" y="2250360"/>
                  <a:ext cx="579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ff0000"/>
                      </a:solidFill>
                      <a:latin typeface="Arial"/>
                    </a:rPr>
                    <a:t>NS5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Text Box 11"/>
                <p:cNvSpPr/>
                <p:nvPr/>
              </p:nvSpPr>
              <p:spPr>
                <a:xfrm>
                  <a:off x="3786120" y="457200"/>
                  <a:ext cx="20624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HCV SG-rep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70" name="Picture 5" descr="121007_7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2070000" y="751680"/>
                  <a:ext cx="1794600" cy="1794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1" name="Text Box 10"/>
                <p:cNvSpPr/>
                <p:nvPr/>
              </p:nvSpPr>
              <p:spPr>
                <a:xfrm>
                  <a:off x="3258000" y="2250360"/>
                  <a:ext cx="579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ff0000"/>
                      </a:solidFill>
                      <a:latin typeface="Arial"/>
                    </a:rPr>
                    <a:t>NS5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Text Box 12"/>
                <p:cNvSpPr/>
                <p:nvPr/>
              </p:nvSpPr>
              <p:spPr>
                <a:xfrm>
                  <a:off x="2557440" y="457200"/>
                  <a:ext cx="819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+ HCVbp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73" name="Picture 13" descr="112907_7_002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5774760" y="751680"/>
                  <a:ext cx="1794600" cy="1794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4" name="Text Box 14"/>
                <p:cNvSpPr/>
                <p:nvPr/>
              </p:nvSpPr>
              <p:spPr>
                <a:xfrm>
                  <a:off x="6963120" y="2250360"/>
                  <a:ext cx="579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ff0000"/>
                      </a:solidFill>
                      <a:latin typeface="Arial"/>
                    </a:rPr>
                    <a:t>NS5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Text Box 15"/>
                <p:cNvSpPr/>
                <p:nvPr/>
              </p:nvSpPr>
              <p:spPr>
                <a:xfrm>
                  <a:off x="6196320" y="457200"/>
                  <a:ext cx="951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uninfect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6" name="Group 31"/>
              <p:cNvGrpSpPr/>
              <p:nvPr/>
            </p:nvGrpSpPr>
            <p:grpSpPr>
              <a:xfrm>
                <a:off x="2084400" y="2784960"/>
                <a:ext cx="5537160" cy="2214000"/>
                <a:chOff x="2084400" y="2784960"/>
                <a:chExt cx="5537160" cy="2214000"/>
              </a:xfrm>
            </p:grpSpPr>
            <p:sp>
              <p:nvSpPr>
                <p:cNvPr id="77" name="Rectangle 29"/>
                <p:cNvSpPr/>
                <p:nvPr/>
              </p:nvSpPr>
              <p:spPr>
                <a:xfrm>
                  <a:off x="2393280" y="2784960"/>
                  <a:ext cx="1269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uninfect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78" name="Picture 61" descr="HUH7.5-FIASH-ReASH control z2Snapshot1.jp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2084400" y="3220920"/>
                  <a:ext cx="1801800" cy="1778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9" name="Rectangle 62"/>
                <p:cNvSpPr/>
                <p:nvPr/>
              </p:nvSpPr>
              <p:spPr>
                <a:xfrm>
                  <a:off x="3254400" y="4699080"/>
                  <a:ext cx="6044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26ff1c"/>
                      </a:solidFill>
                      <a:latin typeface="Arial"/>
                    </a:rPr>
                    <a:t>FIAs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Rectangle 29"/>
                <p:cNvSpPr/>
                <p:nvPr/>
              </p:nvSpPr>
              <p:spPr>
                <a:xfrm>
                  <a:off x="4601880" y="2784960"/>
                  <a:ext cx="2367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HCVbp-4cys infect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81" name="Picture 32" descr="684_CT-FIASH-4_z5-deconvolved_001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3944880" y="3206520"/>
                  <a:ext cx="1792080" cy="17924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2" name="Picture 33" descr="684_CT-ReASH_z6-original_001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5786640" y="3206520"/>
                  <a:ext cx="1792080" cy="17924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3" name="Rectangle 46"/>
                <p:cNvSpPr/>
                <p:nvPr/>
              </p:nvSpPr>
              <p:spPr>
                <a:xfrm>
                  <a:off x="5121360" y="4692600"/>
                  <a:ext cx="6044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26ff1c"/>
                      </a:solidFill>
                      <a:latin typeface="Arial"/>
                    </a:rPr>
                    <a:t>FIAs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Rectangle 47"/>
                <p:cNvSpPr/>
                <p:nvPr/>
              </p:nvSpPr>
              <p:spPr>
                <a:xfrm>
                  <a:off x="6834600" y="4667400"/>
                  <a:ext cx="66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ff0000"/>
                      </a:solidFill>
                      <a:latin typeface="Arial"/>
                    </a:rPr>
                    <a:t>ReAs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AutoShape 38"/>
                <p:cNvSpPr/>
                <p:nvPr/>
              </p:nvSpPr>
              <p:spPr>
                <a:xfrm rot="16200000">
                  <a:off x="5688000" y="1273680"/>
                  <a:ext cx="152280" cy="3714840"/>
                </a:xfrm>
                <a:custGeom>
                  <a:avLst/>
                  <a:gdLst>
                    <a:gd name="textAreaLeft" fmla="*/ 0 w 152280"/>
                    <a:gd name="textAreaRight" fmla="*/ 55080 w 152280"/>
                    <a:gd name="textAreaTop" fmla="*/ 42840 h 3714840"/>
                    <a:gd name="textAreaBottom" fmla="*/ 3672000 h 371484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5400" y="0"/>
                        <a:pt x="10800" y="400"/>
                        <a:pt x="10800" y="800"/>
                      </a:cubicBezTo>
                      <a:lnTo>
                        <a:pt x="10800" y="10000"/>
                      </a:lnTo>
                      <a:cubicBezTo>
                        <a:pt x="10800" y="10400"/>
                        <a:pt x="16200" y="10800"/>
                        <a:pt x="21600" y="10800"/>
                      </a:cubicBezTo>
                      <a:cubicBezTo>
                        <a:pt x="16200" y="10800"/>
                        <a:pt x="10800" y="11200"/>
                        <a:pt x="10800" y="11600"/>
                      </a:cubicBezTo>
                      <a:lnTo>
                        <a:pt x="10800" y="20800"/>
                      </a:lnTo>
                      <a:cubicBezTo>
                        <a:pt x="10800" y="21200"/>
                        <a:pt x="54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6" name="TextBox 30"/>
              <p:cNvSpPr/>
              <p:nvPr/>
            </p:nvSpPr>
            <p:spPr>
              <a:xfrm>
                <a:off x="1522440" y="2791080"/>
                <a:ext cx="351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8T07:00:19Z</dcterms:created>
  <dc:creator>bertrand saunier</dc:creator>
  <dc:description/>
  <dc:language>en-US</dc:language>
  <cp:lastModifiedBy>bertrand saunier</cp:lastModifiedBy>
  <dcterms:modified xsi:type="dcterms:W3CDTF">2011-03-10T14:23:22Z</dcterms:modified>
  <cp:revision>139</cp:revision>
  <dc:subject/>
  <dc:title>Slide 1</dc:title>
</cp:coreProperties>
</file>